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9B10C-C24B-4030-9DD9-918F13FAB6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BE84B-4D7D-4EB1-B84B-0D1036B0FA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6B169-6C51-476C-A673-6557B6334C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59A67-395F-4822-B019-D80B63E39B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44D1D-F6FB-416C-81E7-6898B1BABE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C2415-D2FE-46A2-93F8-789E2DC1BB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F6519-C1A9-4BCC-85D2-30A40F99B7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F928B-C2C4-4CDA-A850-45B1B3C585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1AA7F-F65A-42AA-BD08-1869D783B4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71A0D-3D89-48F2-B585-9A999BD3B3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70C82-0E37-42BE-B9E5-2474D62B3F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418DB-5E8E-4D5F-8121-732AEF3427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A15579-4505-4F71-BAD4-164B4747A0AC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1"/>
          <p:cNvSpPr/>
          <p:nvPr/>
        </p:nvSpPr>
        <p:spPr>
          <a:xfrm>
            <a:off x="228600" y="228600"/>
            <a:ext cx="12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933480" y="2666880"/>
            <a:ext cx="5257800" cy="77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78000" y="914400"/>
            <a:ext cx="5989320" cy="1572840"/>
            <a:chOff x="378000" y="914400"/>
            <a:chExt cx="5989320" cy="1572840"/>
          </a:xfrm>
        </p:grpSpPr>
        <p:grpSp>
          <p:nvGrpSpPr>
            <p:cNvPr id="44" name="Group 24"/>
            <p:cNvGrpSpPr/>
            <p:nvPr/>
          </p:nvGrpSpPr>
          <p:grpSpPr>
            <a:xfrm>
              <a:off x="536400" y="2281320"/>
              <a:ext cx="5817960" cy="205920"/>
              <a:chOff x="536400" y="2281320"/>
              <a:chExt cx="5817960" cy="205920"/>
            </a:xfrm>
          </p:grpSpPr>
          <p:grpSp>
            <p:nvGrpSpPr>
              <p:cNvPr id="45" name="Group 5"/>
              <p:cNvGrpSpPr/>
              <p:nvPr/>
            </p:nvGrpSpPr>
            <p:grpSpPr>
              <a:xfrm>
                <a:off x="536400" y="2281320"/>
                <a:ext cx="1067400" cy="203040"/>
                <a:chOff x="536400" y="2281320"/>
                <a:chExt cx="1067400" cy="203040"/>
              </a:xfrm>
            </p:grpSpPr>
            <p:sp>
              <p:nvSpPr>
                <p:cNvPr id="46" name="Rectangle 6"/>
                <p:cNvSpPr/>
                <p:nvPr/>
              </p:nvSpPr>
              <p:spPr>
                <a:xfrm>
                  <a:off x="581400" y="2305080"/>
                  <a:ext cx="1022400" cy="135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7160" bIns="47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     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 motif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Rectangle 7"/>
                <p:cNvSpPr/>
                <p:nvPr/>
              </p:nvSpPr>
              <p:spPr>
                <a:xfrm>
                  <a:off x="536400" y="2281320"/>
                  <a:ext cx="271800" cy="203040"/>
                </a:xfrm>
                <a:prstGeom prst="rect">
                  <a:avLst/>
                </a:prstGeom>
                <a:solidFill>
                  <a:srgbClr val="ffff00"/>
                </a:solidFill>
                <a:ln w="936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7160" bIns="471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8" name="Rectangle 9"/>
              <p:cNvSpPr/>
              <p:nvPr/>
            </p:nvSpPr>
            <p:spPr>
              <a:xfrm>
                <a:off x="1555560" y="2281320"/>
                <a:ext cx="271800" cy="203040"/>
              </a:xfrm>
              <a:prstGeom prst="rect">
                <a:avLst/>
              </a:prstGeom>
              <a:solidFill>
                <a:srgbClr val="00cc00"/>
              </a:solidFill>
              <a:ln w="9360">
                <a:solidFill>
                  <a:srgbClr val="00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10"/>
              <p:cNvSpPr/>
              <p:nvPr/>
            </p:nvSpPr>
            <p:spPr>
              <a:xfrm>
                <a:off x="1611000" y="2307960"/>
                <a:ext cx="1022400" cy="13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"/>
                  </a:rPr>
                  <a:t>  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B moti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2"/>
              <p:cNvSpPr/>
              <p:nvPr/>
            </p:nvSpPr>
            <p:spPr>
              <a:xfrm>
                <a:off x="2575080" y="2284200"/>
                <a:ext cx="271800" cy="203040"/>
              </a:xfrm>
              <a:prstGeom prst="rect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13"/>
              <p:cNvSpPr/>
              <p:nvPr/>
            </p:nvSpPr>
            <p:spPr>
              <a:xfrm>
                <a:off x="2620080" y="2298960"/>
                <a:ext cx="1022040" cy="135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"/>
                  </a:rPr>
                  <a:t> 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 moti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5"/>
              <p:cNvSpPr/>
              <p:nvPr/>
            </p:nvSpPr>
            <p:spPr>
              <a:xfrm>
                <a:off x="3601440" y="2281320"/>
                <a:ext cx="272160" cy="20304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16"/>
              <p:cNvSpPr/>
              <p:nvPr/>
            </p:nvSpPr>
            <p:spPr>
              <a:xfrm>
                <a:off x="3654360" y="2298960"/>
                <a:ext cx="1022040" cy="135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"/>
                  </a:rPr>
                  <a:t> 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 moti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8"/>
              <p:cNvSpPr/>
              <p:nvPr/>
            </p:nvSpPr>
            <p:spPr>
              <a:xfrm>
                <a:off x="4595400" y="2281320"/>
                <a:ext cx="271800" cy="203040"/>
              </a:xfrm>
              <a:prstGeom prst="rect">
                <a:avLst/>
              </a:prstGeom>
              <a:solidFill>
                <a:srgbClr val="008000"/>
              </a:solidFill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19"/>
              <p:cNvSpPr/>
              <p:nvPr/>
            </p:nvSpPr>
            <p:spPr>
              <a:xfrm>
                <a:off x="4638960" y="2298960"/>
                <a:ext cx="1022400" cy="135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"/>
                  </a:rPr>
                  <a:t> 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 moti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21"/>
              <p:cNvSpPr/>
              <p:nvPr/>
            </p:nvSpPr>
            <p:spPr>
              <a:xfrm>
                <a:off x="5639040" y="2281320"/>
                <a:ext cx="271800" cy="20304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96969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22"/>
              <p:cNvSpPr/>
              <p:nvPr/>
            </p:nvSpPr>
            <p:spPr>
              <a:xfrm>
                <a:off x="5684040" y="2316960"/>
                <a:ext cx="670320" cy="134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7160" bIns="47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Arial"/>
                  </a:rPr>
                  <a:t>     </a:t>
                </a:r>
                <a:r>
                  <a:rPr b="0" lang="zh-CN" sz="800" spc="-1" strike="noStrike">
                    <a:solidFill>
                      <a:srgbClr val="ffffff"/>
                    </a:solidFill>
                    <a:latin typeface="Arial"/>
                  </a:rPr>
                  <a:t>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A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8" name="Picture 4" descr=""/>
            <p:cNvPicPr/>
            <p:nvPr/>
          </p:nvPicPr>
          <p:blipFill>
            <a:blip r:embed="rId1"/>
            <a:stretch/>
          </p:blipFill>
          <p:spPr>
            <a:xfrm>
              <a:off x="378000" y="914400"/>
              <a:ext cx="5989320" cy="128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Line 25"/>
            <p:cNvSpPr/>
            <p:nvPr/>
          </p:nvSpPr>
          <p:spPr>
            <a:xfrm>
              <a:off x="3138480" y="1965600"/>
              <a:ext cx="1863720" cy="0"/>
            </a:xfrm>
            <a:prstGeom prst="line">
              <a:avLst/>
            </a:prstGeom>
            <a:ln w="190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905040" y="2730600"/>
            <a:ext cx="5257800" cy="375444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314280" y="2736720"/>
            <a:ext cx="696960" cy="61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14280" y="3490920"/>
            <a:ext cx="696960" cy="62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14280" y="4275000"/>
            <a:ext cx="696960" cy="61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14280" y="5030640"/>
            <a:ext cx="696960" cy="61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04920" y="5784840"/>
            <a:ext cx="696960" cy="62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0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AC0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113520" y="2736720"/>
            <a:ext cx="309600" cy="61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113520" y="3490920"/>
            <a:ext cx="309600" cy="62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113520" y="4265640"/>
            <a:ext cx="309600" cy="61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2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113520" y="5000760"/>
            <a:ext cx="309600" cy="62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9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6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6113520" y="5762520"/>
            <a:ext cx="309600" cy="61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6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9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5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4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066680" y="2743200"/>
            <a:ext cx="1524240" cy="0"/>
          </a:xfrm>
          <a:prstGeom prst="line">
            <a:avLst/>
          </a:prstGeom>
          <a:ln w="284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76720" y="2743200"/>
            <a:ext cx="990360" cy="0"/>
          </a:xfrm>
          <a:prstGeom prst="line">
            <a:avLst/>
          </a:prstGeom>
          <a:ln w="2844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857840" y="2743200"/>
            <a:ext cx="1253880" cy="0"/>
          </a:xfrm>
          <a:prstGeom prst="line">
            <a:avLst/>
          </a:prstGeom>
          <a:ln w="2844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955800" y="3505320"/>
            <a:ext cx="949320" cy="0"/>
          </a:xfrm>
          <a:prstGeom prst="line">
            <a:avLst/>
          </a:prstGeom>
          <a:ln w="2844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540160" y="3505320"/>
            <a:ext cx="180324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849920" y="3505320"/>
            <a:ext cx="865080" cy="0"/>
          </a:xfrm>
          <a:prstGeom prst="line">
            <a:avLst/>
          </a:prstGeom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025720" y="5029200"/>
            <a:ext cx="131112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1"/>
          <p:cNvSpPr/>
          <p:nvPr/>
        </p:nvSpPr>
        <p:spPr>
          <a:xfrm>
            <a:off x="514440" y="790560"/>
            <a:ext cx="2347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1"/>
          <p:cNvSpPr/>
          <p:nvPr/>
        </p:nvSpPr>
        <p:spPr>
          <a:xfrm>
            <a:off x="466560" y="2590920"/>
            <a:ext cx="2350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267080" y="5791320"/>
            <a:ext cx="1295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4" descr=""/>
          <p:cNvPicPr/>
          <p:nvPr/>
        </p:nvPicPr>
        <p:blipFill>
          <a:blip r:embed="rId1"/>
          <a:stretch/>
        </p:blipFill>
        <p:spPr>
          <a:xfrm>
            <a:off x="357120" y="1547640"/>
            <a:ext cx="5938920" cy="256572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6" descr=""/>
          <p:cNvPicPr/>
          <p:nvPr/>
        </p:nvPicPr>
        <p:blipFill>
          <a:blip r:embed="rId2"/>
          <a:stretch/>
        </p:blipFill>
        <p:spPr>
          <a:xfrm>
            <a:off x="811080" y="4344840"/>
            <a:ext cx="5513400" cy="21132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7" descr=""/>
          <p:cNvPicPr/>
          <p:nvPr/>
        </p:nvPicPr>
        <p:blipFill>
          <a:blip r:embed="rId3"/>
          <a:stretch/>
        </p:blipFill>
        <p:spPr>
          <a:xfrm>
            <a:off x="809640" y="4129200"/>
            <a:ext cx="5514840" cy="207720"/>
          </a:xfrm>
          <a:prstGeom prst="rect">
            <a:avLst/>
          </a:prstGeom>
          <a:ln w="0">
            <a:noFill/>
          </a:ln>
        </p:spPr>
      </p:pic>
      <p:sp>
        <p:nvSpPr>
          <p:cNvPr id="84" name="Rectangle 9"/>
          <p:cNvSpPr/>
          <p:nvPr/>
        </p:nvSpPr>
        <p:spPr>
          <a:xfrm>
            <a:off x="538200" y="4557600"/>
            <a:ext cx="5938920" cy="22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7160" bIns="471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             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12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6  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1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 L5  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2  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8 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 L4 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20     </a:t>
            </a: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0"/>
          <p:cNvSpPr/>
          <p:nvPr/>
        </p:nvSpPr>
        <p:spPr>
          <a:xfrm flipV="1">
            <a:off x="1546200" y="4765680"/>
            <a:ext cx="4633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1"/>
          <p:cNvSpPr/>
          <p:nvPr/>
        </p:nvSpPr>
        <p:spPr>
          <a:xfrm>
            <a:off x="3476520" y="4782960"/>
            <a:ext cx="1017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7160" bIns="47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800" spc="-1" strike="noStrike">
                <a:solidFill>
                  <a:srgbClr val="000000"/>
                </a:solidFill>
                <a:latin typeface="Arial"/>
              </a:rPr>
              <a:t>35S::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26"/>
          <p:cNvSpPr/>
          <p:nvPr/>
        </p:nvSpPr>
        <p:spPr>
          <a:xfrm>
            <a:off x="752400" y="4624560"/>
            <a:ext cx="712800" cy="24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7160" bIns="47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34"/>
          <p:cNvSpPr/>
          <p:nvPr/>
        </p:nvSpPr>
        <p:spPr>
          <a:xfrm>
            <a:off x="6205680" y="3579840"/>
            <a:ext cx="0" cy="37476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3"/>
          <p:cNvSpPr/>
          <p:nvPr/>
        </p:nvSpPr>
        <p:spPr>
          <a:xfrm>
            <a:off x="304920" y="228600"/>
            <a:ext cx="121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31120" y="4129200"/>
            <a:ext cx="63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NAC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06720" y="4343400"/>
            <a:ext cx="53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UBC30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 Box 13"/>
          <p:cNvSpPr/>
          <p:nvPr/>
        </p:nvSpPr>
        <p:spPr>
          <a:xfrm>
            <a:off x="380880" y="304920"/>
            <a:ext cx="12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4" descr=""/>
          <p:cNvPicPr/>
          <p:nvPr/>
        </p:nvPicPr>
        <p:blipFill>
          <a:blip r:embed="rId1"/>
          <a:stretch/>
        </p:blipFill>
        <p:spPr>
          <a:xfrm>
            <a:off x="1863720" y="1219320"/>
            <a:ext cx="2795760" cy="148572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5" descr=""/>
          <p:cNvPicPr/>
          <p:nvPr/>
        </p:nvPicPr>
        <p:blipFill>
          <a:blip r:embed="rId2"/>
          <a:stretch/>
        </p:blipFill>
        <p:spPr>
          <a:xfrm>
            <a:off x="1863720" y="2819520"/>
            <a:ext cx="2825640" cy="1476360"/>
          </a:xfrm>
          <a:prstGeom prst="rect">
            <a:avLst/>
          </a:prstGeom>
          <a:ln w="0">
            <a:noFill/>
          </a:ln>
        </p:spPr>
      </p:pic>
      <p:sp>
        <p:nvSpPr>
          <p:cNvPr id="95" name="Rectangle 11"/>
          <p:cNvSpPr/>
          <p:nvPr/>
        </p:nvSpPr>
        <p:spPr>
          <a:xfrm>
            <a:off x="1863720" y="1219320"/>
            <a:ext cx="2350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2"/>
          <p:cNvSpPr/>
          <p:nvPr/>
        </p:nvSpPr>
        <p:spPr>
          <a:xfrm>
            <a:off x="1879560" y="2909880"/>
            <a:ext cx="236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16" descr=""/>
          <p:cNvPicPr/>
          <p:nvPr/>
        </p:nvPicPr>
        <p:blipFill>
          <a:blip r:embed="rId3"/>
          <a:stretch/>
        </p:blipFill>
        <p:spPr>
          <a:xfrm>
            <a:off x="1809720" y="4390920"/>
            <a:ext cx="2860560" cy="1548000"/>
          </a:xfrm>
          <a:prstGeom prst="rect">
            <a:avLst/>
          </a:prstGeom>
          <a:ln w="0">
            <a:noFill/>
          </a:ln>
        </p:spPr>
      </p:pic>
      <p:sp>
        <p:nvSpPr>
          <p:cNvPr id="98" name="Rectangle 17"/>
          <p:cNvSpPr/>
          <p:nvPr/>
        </p:nvSpPr>
        <p:spPr>
          <a:xfrm>
            <a:off x="1901880" y="4390920"/>
            <a:ext cx="2347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032360" y="2590920"/>
            <a:ext cx="53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038480" y="4191120"/>
            <a:ext cx="540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038480" y="5867280"/>
            <a:ext cx="540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nknown</cp:lastModifiedBy>
  <dcterms:modified xsi:type="dcterms:W3CDTF">2015-04-30T04:21:36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